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8" r:id="rId3"/>
    <p:sldId id="273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96" userDrawn="1">
          <p15:clr>
            <a:srgbClr val="A4A3A4"/>
          </p15:clr>
        </p15:guide>
        <p15:guide id="2" pos="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9" autoAdjust="0"/>
    <p:restoredTop sz="96327"/>
  </p:normalViewPr>
  <p:slideViewPr>
    <p:cSldViewPr snapToGrid="0" snapToObjects="1" showGuides="1">
      <p:cViewPr varScale="1">
        <p:scale>
          <a:sx n="64" d="100"/>
          <a:sy n="64" d="100"/>
        </p:scale>
        <p:origin x="728" y="56"/>
      </p:cViewPr>
      <p:guideLst>
        <p:guide orient="horz" pos="696"/>
        <p:guide pos="288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C5293-7901-A44C-8DC5-0C8D226998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B6BF52-7C46-D941-AC34-59297AD471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712088-7E98-5440-BBAD-CE5E46B28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1B8A5-1851-C04E-A10A-02BC484B6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37B02E-9F0B-7944-8D13-FC248CFB0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7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9D596-91BA-D245-9854-69C7ED453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214A4A-EB04-3D40-9EB1-24FB271DA9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3D254-4732-384F-A065-80E9BC8EA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81B951-EF10-B849-9524-CD4E75562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3A7B06-081C-5545-BC5C-EDC075C92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257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87E786-F6C3-CB45-BB38-033C0EF568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656791-B66E-1747-97E1-96C3A7C761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3FE8B0-A237-D447-9DCD-FB11C1D8F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1044AE-88AF-6548-B2DF-2CDBC72C5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EA421-9C42-EF4D-A2A3-A72B0C73A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807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2FB8A-2BB9-EE42-9203-FAEDE8477E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1EF982-47E9-4D44-AA8C-00D32DFDC2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C11F08-4FC1-FE42-B800-792232F01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3B82E-36A3-014D-95E8-112E8DB7F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011DEF-2089-0B45-BC57-4B09A71E1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794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D024F-AC15-6B42-8635-298D97F99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490481-B563-874B-8C25-95FAB505DA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6D567-3971-3243-B01C-6AE63B293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001FE7-5A16-5247-B233-356C7389A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C2607-318D-9444-87B3-03EA8CAAE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09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D5328-DEFD-FF4D-A385-995EF2678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85D1C2-0AC8-FB4E-8666-7DA6CA8EA6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49FFB4-CC3B-1043-B1E9-7178632BCC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20B584-017A-D047-927B-E4A61FE2E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EBC000-BF06-6143-B92E-A59CA9C84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EB410E-54ED-5144-B31E-EC0129986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853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63B69-0B33-144C-9BC5-6B656EA3B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630239-2FDF-0541-B452-288EA036B1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428F84-D334-D640-8263-6C49637393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BCF600-602E-0243-A8AB-2363504965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D6AF52-6713-164E-B3BF-0D53A178C1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C89CA2-9880-644E-9A7C-D71871B00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ECDF88-7F80-F341-91F2-FD30D5EBD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D6DD11-DC83-B447-9B99-1BDCFAF62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125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D4DC3-E9C9-ED42-8EED-D46B2D668F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4AF16C-D152-F34D-A8E2-8D7402A18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A0F86C-990C-204D-9994-B878259F0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72FE7D-5301-7740-968A-C6DCABBCA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356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A48E59-4999-A840-B37E-52BB0A768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41790A-74A4-8240-89FA-612D02FEC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016284-AC30-1E4E-B912-C19F1F18B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980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3091C-CC01-5D4D-98B0-615499FFD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7B629E-0D7F-BC44-9F7E-7196EA0F7D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DDCFA7-D063-9143-A50A-C2E8B69304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C84596-1A0D-5940-858E-DA402D6DA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68ACF-31E3-8A4D-AA8C-9DB7E01FD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AA4B05-DA1E-AC40-A18C-5E5DFDF38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771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B030E3-9F22-C441-A695-A2A78582C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ABACED-EA86-084B-8BF3-C05676DE2F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2BF36D-5B88-CE45-9989-358C16A356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027062-DE7A-0947-9DA7-3481B97F0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8B72E5-7905-BB4E-81F8-46932FDCC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1720AB-CA79-CC45-83DE-5B6EA6EC2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956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002DD0-8AE2-B448-895F-08F54B7A5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B08BB1-50A6-D54B-80AC-6EC0291970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FEE75-1300-A747-9622-D459B6C6F8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823B1-F0A1-CC44-9189-D8C33BD32B73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360E04-98B7-6446-BA92-D828AFC1C1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12C2E-AE99-1F45-9971-AD9F1D95BF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FC833-1817-6E46-8366-C60C36315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124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15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12" Type="http://schemas.openxmlformats.org/officeDocument/2006/relationships/image" Target="../media/image14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7.emf"/><Relationship Id="rId15" Type="http://schemas.openxmlformats.org/officeDocument/2006/relationships/image" Target="../media/image1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Relationship Id="rId1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9699D3-AE14-0A47-9063-FD1D64DB0316}"/>
              </a:ext>
            </a:extLst>
          </p:cNvPr>
          <p:cNvSpPr txBox="1"/>
          <p:nvPr/>
        </p:nvSpPr>
        <p:spPr>
          <a:xfrm>
            <a:off x="277584" y="281731"/>
            <a:ext cx="112177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Animal </a:t>
            </a:r>
            <a:r>
              <a:rPr lang="en-GB" b="1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omplete blood count (</a:t>
            </a:r>
            <a:r>
              <a:rPr lang="en-US" b="1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BC) at the end of 2 weeks of sham or 150 kHz TTFields application.</a:t>
            </a:r>
            <a:r>
              <a:rPr lang="en-US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</a:p>
          <a:p>
            <a:pPr algn="just"/>
            <a:r>
              <a:rPr lang="en-GB" dirty="0"/>
              <a:t>Average ± standard deviations at study end are shown for control animals versus animals treated with TTFields . </a:t>
            </a:r>
            <a:r>
              <a:rPr lang="en-GB" i="1" dirty="0"/>
              <a:t>(WBC, white blood cells; RBC, red blood cells; HGB, haemoglobin; MCV, mean corpuscular volume; MCH, mean corpuscular haemoglobin; MCHC, MCH concentration.) </a:t>
            </a:r>
            <a:endParaRPr lang="en-US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D0C48F7-8AFC-49B5-93D1-E70FDB4A0B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6894" y="1861668"/>
            <a:ext cx="840769" cy="47590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71072AB-EE65-4C59-98E4-C9A945A0A9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2438" y="1482060"/>
            <a:ext cx="5163601" cy="5375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654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B4D25DC-A297-45D0-935F-B0BB831371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237" y="1292086"/>
            <a:ext cx="5810052" cy="556591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D152F50-F719-2A4E-83CC-38F2493BC448}"/>
              </a:ext>
            </a:extLst>
          </p:cNvPr>
          <p:cNvSpPr txBox="1"/>
          <p:nvPr/>
        </p:nvSpPr>
        <p:spPr>
          <a:xfrm>
            <a:off x="253019" y="205192"/>
            <a:ext cx="116859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  <a:r>
              <a:rPr lang="en-GB" b="1" dirty="0"/>
              <a:t>. Animal blood biochemistry </a:t>
            </a:r>
            <a:r>
              <a:rPr lang="en-US" b="1" dirty="0"/>
              <a:t>at the end of 2 weeks of sham or 150 kHz TTFields treatment</a:t>
            </a:r>
            <a:r>
              <a:rPr lang="en-GB" b="1" dirty="0"/>
              <a:t>. </a:t>
            </a:r>
          </a:p>
          <a:p>
            <a:pPr algn="just"/>
            <a:r>
              <a:rPr lang="en-GB" dirty="0"/>
              <a:t>Average ± standard deviations at study end are shown for control animals versus animals treated with TTFields. </a:t>
            </a:r>
            <a:r>
              <a:rPr lang="en-GB" i="1" dirty="0"/>
              <a:t>(LDH, lactate dehydrogenase; GGT, gamma-glutamyl transferase; ALP, alkaline phosphatase; ALT, alanine aminotransferase; AST, aspartate aminotransferase; CPK, creatinine phosphokinase.) </a:t>
            </a:r>
            <a:endParaRPr lang="en-US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78F5F79-0B92-4D13-8D84-1B6006D1F0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6894" y="1861668"/>
            <a:ext cx="840769" cy="4759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7991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ctangle 58">
            <a:extLst>
              <a:ext uri="{FF2B5EF4-FFF2-40B4-BE49-F238E27FC236}">
                <a16:creationId xmlns:a16="http://schemas.microsoft.com/office/drawing/2014/main" id="{7A77A55B-ECE3-4E4D-8C0C-F22CB059E649}"/>
              </a:ext>
            </a:extLst>
          </p:cNvPr>
          <p:cNvSpPr/>
          <p:nvPr/>
        </p:nvSpPr>
        <p:spPr>
          <a:xfrm>
            <a:off x="3246342" y="1047104"/>
            <a:ext cx="1150095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udenum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D3C834C6-EF75-4A40-8A1E-078E039FC701}"/>
              </a:ext>
            </a:extLst>
          </p:cNvPr>
          <p:cNvSpPr/>
          <p:nvPr/>
        </p:nvSpPr>
        <p:spPr>
          <a:xfrm>
            <a:off x="4772451" y="3358586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omach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2B65125A-EC5B-4C43-BC6E-C7088C22B1A7}"/>
              </a:ext>
            </a:extLst>
          </p:cNvPr>
          <p:cNvSpPr/>
          <p:nvPr/>
        </p:nvSpPr>
        <p:spPr>
          <a:xfrm>
            <a:off x="3406193" y="3358586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on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57EC258-B380-41AC-AE0A-9DABDAE9319F}"/>
              </a:ext>
            </a:extLst>
          </p:cNvPr>
          <p:cNvSpPr/>
          <p:nvPr/>
        </p:nvSpPr>
        <p:spPr>
          <a:xfrm>
            <a:off x="7513510" y="1047104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cum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33C4C98-B12A-4EC4-BDA5-B6981EFF0E4D}"/>
              </a:ext>
            </a:extLst>
          </p:cNvPr>
          <p:cNvSpPr/>
          <p:nvPr/>
        </p:nvSpPr>
        <p:spPr>
          <a:xfrm>
            <a:off x="6137382" y="3358586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80053D-382D-6943-964C-AE8283B3D3B3}"/>
              </a:ext>
            </a:extLst>
          </p:cNvPr>
          <p:cNvSpPr txBox="1"/>
          <p:nvPr/>
        </p:nvSpPr>
        <p:spPr>
          <a:xfrm>
            <a:off x="32647" y="176282"/>
            <a:ext cx="122691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</a:t>
            </a:r>
            <a:r>
              <a:rPr lang="en-GB" b="1" dirty="0">
                <a:latin typeface="Calibri" panose="020F0502020204030204" pitchFamily="34" charset="0"/>
                <a:ea typeface="SimSun" panose="02010600030101010101" pitchFamily="2" charset="-122"/>
              </a:rPr>
              <a:t>Histopathology analysis of GI tract organs from animals </a:t>
            </a:r>
            <a:r>
              <a:rPr lang="en-US" b="1" dirty="0">
                <a:latin typeface="Calibri" panose="020F0502020204030204" pitchFamily="34" charset="0"/>
                <a:ea typeface="SimSun" panose="02010600030101010101" pitchFamily="2" charset="-122"/>
              </a:rPr>
              <a:t>at the end of 2 weeks of sham or 150 kHz TTFields treatment</a:t>
            </a:r>
            <a:r>
              <a:rPr lang="en-GB" dirty="0">
                <a:latin typeface="Calibri" panose="020F0502020204030204" pitchFamily="34" charset="0"/>
                <a:ea typeface="SimSun" panose="02010600030101010101" pitchFamily="2" charset="-122"/>
              </a:rPr>
              <a:t>. </a:t>
            </a:r>
            <a:r>
              <a:rPr lang="en-GB" dirty="0"/>
              <a:t>Images from one representative animal from each group are shown (H&amp;E staining, ×20 magnification).</a:t>
            </a:r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8E4D58D-5AB2-4C7A-90EC-3B3DF6449E40}"/>
              </a:ext>
            </a:extLst>
          </p:cNvPr>
          <p:cNvSpPr/>
          <p:nvPr/>
        </p:nvSpPr>
        <p:spPr>
          <a:xfrm>
            <a:off x="4772451" y="1047104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eum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93F4E68-9D18-4673-99F0-98D4B540741A}"/>
              </a:ext>
            </a:extLst>
          </p:cNvPr>
          <p:cNvSpPr/>
          <p:nvPr/>
        </p:nvSpPr>
        <p:spPr>
          <a:xfrm>
            <a:off x="6137382" y="1047104"/>
            <a:ext cx="830393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8000" rIns="0" bIns="18000" rtlCol="0" anchor="ctr">
            <a:spAutoFit/>
          </a:bodyPr>
          <a:lstStyle/>
          <a:p>
            <a:pPr algn="ctr"/>
            <a:r>
              <a:rPr lang="pt-BR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ejunum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870C1DDE-B221-42C0-80ED-6B9FA9E3C7F2}"/>
              </a:ext>
            </a:extLst>
          </p:cNvPr>
          <p:cNvSpPr/>
          <p:nvPr/>
        </p:nvSpPr>
        <p:spPr>
          <a:xfrm>
            <a:off x="2237533" y="1688939"/>
            <a:ext cx="779708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r>
              <a:rPr lang="en-I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604C6FDE-4100-4AEA-B245-4233A2EA6135}"/>
              </a:ext>
            </a:extLst>
          </p:cNvPr>
          <p:cNvSpPr/>
          <p:nvPr/>
        </p:nvSpPr>
        <p:spPr>
          <a:xfrm>
            <a:off x="2183328" y="2583369"/>
            <a:ext cx="833913" cy="528794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pPr algn="ctr"/>
            <a:r>
              <a:rPr lang="en-I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 kHz TTFields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2ACD92C1-8F04-4378-9A36-B97CD064BF5C}"/>
              </a:ext>
            </a:extLst>
          </p:cNvPr>
          <p:cNvSpPr/>
          <p:nvPr/>
        </p:nvSpPr>
        <p:spPr>
          <a:xfrm>
            <a:off x="2237533" y="3976336"/>
            <a:ext cx="779708" cy="28257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r>
              <a:rPr lang="en-I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13C4F097-7470-40E8-A037-10E18CC86C66}"/>
              </a:ext>
            </a:extLst>
          </p:cNvPr>
          <p:cNvSpPr/>
          <p:nvPr/>
        </p:nvSpPr>
        <p:spPr>
          <a:xfrm>
            <a:off x="2183328" y="4874413"/>
            <a:ext cx="833913" cy="528794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18000" rIns="0" bIns="18000" rtlCol="0" anchor="ctr">
            <a:spAutoFit/>
          </a:bodyPr>
          <a:lstStyle/>
          <a:p>
            <a:pPr algn="ctr"/>
            <a:r>
              <a:rPr lang="en-I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 kHz TTField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34F383-D410-485A-B9D2-74F4D485FE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0494" y="4634747"/>
            <a:ext cx="1344168" cy="100812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FADE0C7-A068-4BA5-9622-EC76DDFCB2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2018" y="3614702"/>
            <a:ext cx="1341120" cy="10058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6A7D014-E707-4280-A58A-23A159D0C3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7087" y="4635890"/>
            <a:ext cx="1341120" cy="10058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3637605-2F47-4377-A4B6-CACE070106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7087" y="3614702"/>
            <a:ext cx="1341120" cy="10058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E4679FC-FA00-412E-AF66-4B5903AC60D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50829" y="2344846"/>
            <a:ext cx="1341120" cy="10058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56F5A27-9A34-47F2-882D-A4C130863C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50829" y="1327305"/>
            <a:ext cx="1341120" cy="100584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6347378-5C45-45A7-A6ED-8400434A7F1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82018" y="2344846"/>
            <a:ext cx="1341120" cy="10058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192D0F9-0382-4277-BEA4-EE4D589FDBD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82018" y="1327305"/>
            <a:ext cx="1341120" cy="100584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93B2D98-6226-461B-B0CA-92686EBB34A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7087" y="2344846"/>
            <a:ext cx="1341120" cy="10058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45B7C82-68ED-403C-B979-1596D2662CD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17087" y="1327305"/>
            <a:ext cx="1341120" cy="10058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ADBE257-1AB1-44B6-94D1-3CC2F725C6F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58146" y="2344846"/>
            <a:ext cx="1341120" cy="10058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DFD4267-6F65-4FA0-8FDB-B019F883EB1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258146" y="1327305"/>
            <a:ext cx="1341120" cy="10058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BD94A94-981C-47BE-9B7B-9746C097600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50829" y="4635890"/>
            <a:ext cx="1341120" cy="10058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593DBCA-DF8C-4FD1-92B4-B01F54937C9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50829" y="3614702"/>
            <a:ext cx="1341120" cy="1005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0515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F20A0B1-CB18-44EE-8FB4-7739763BF7E8}"/>
              </a:ext>
            </a:extLst>
          </p:cNvPr>
          <p:cNvSpPr txBox="1"/>
          <p:nvPr/>
        </p:nvSpPr>
        <p:spPr>
          <a:xfrm>
            <a:off x="135924" y="145492"/>
            <a:ext cx="119290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</a:t>
            </a:r>
            <a:r>
              <a:rPr lang="en-GB" b="1" dirty="0"/>
              <a:t>.</a:t>
            </a:r>
            <a:r>
              <a:rPr lang="en-GB" dirty="0"/>
              <a:t> </a:t>
            </a:r>
            <a:r>
              <a:rPr lang="en-GB" b="1" dirty="0"/>
              <a:t>Simulations of EF intensities in the rat torso during 150 kHz TTFields application.</a:t>
            </a:r>
            <a:r>
              <a:rPr lang="en-GB" dirty="0"/>
              <a:t> </a:t>
            </a:r>
          </a:p>
          <a:p>
            <a:pPr algn="just"/>
            <a:r>
              <a:rPr lang="en-GB" dirty="0"/>
              <a:t>EF intensity distribution simulated for 150 kHz TTFields at the current determined relevant from the </a:t>
            </a:r>
            <a:r>
              <a:rPr lang="en-GB" i="1" dirty="0"/>
              <a:t>in vivo</a:t>
            </a:r>
            <a:r>
              <a:rPr lang="en-GB" dirty="0"/>
              <a:t> study of 250 mA, shown from a side view for each of the 2 array pairs and as a </a:t>
            </a:r>
            <a:r>
              <a:rPr lang="en-GB"/>
              <a:t>merged average image </a:t>
            </a:r>
            <a:r>
              <a:rPr lang="en-GB" dirty="0"/>
              <a:t>of both.</a:t>
            </a:r>
            <a:endParaRPr lang="en-US" b="1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6C2702C-AECD-445C-81BD-216E393ECF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5" t="4254" r="7078" b="14109"/>
          <a:stretch/>
        </p:blipFill>
        <p:spPr>
          <a:xfrm>
            <a:off x="2947232" y="1697488"/>
            <a:ext cx="4754880" cy="1362935"/>
          </a:xfrm>
          <a:prstGeom prst="rect">
            <a:avLst/>
          </a:prstGeom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FEB1725E-6D84-4814-B604-CAC8AB6B8D20}"/>
              </a:ext>
            </a:extLst>
          </p:cNvPr>
          <p:cNvGrpSpPr/>
          <p:nvPr/>
        </p:nvGrpSpPr>
        <p:grpSpPr>
          <a:xfrm>
            <a:off x="3022959" y="1686051"/>
            <a:ext cx="970182" cy="762345"/>
            <a:chOff x="2124889" y="4708723"/>
            <a:chExt cx="970182" cy="762345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4C3D09C-B02D-4322-97A4-348E14B4A93E}"/>
                </a:ext>
              </a:extLst>
            </p:cNvPr>
            <p:cNvSpPr txBox="1"/>
            <p:nvPr/>
          </p:nvSpPr>
          <p:spPr>
            <a:xfrm>
              <a:off x="2201876" y="4708723"/>
              <a:ext cx="893195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3 V/cm RMS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98C6AF0-BD9C-4A46-AD6D-06578FE653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24889" y="4815516"/>
              <a:ext cx="132109" cy="527963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8AA2BF3-EC81-4B29-B659-B40199F247B6}"/>
                </a:ext>
              </a:extLst>
            </p:cNvPr>
            <p:cNvSpPr txBox="1"/>
            <p:nvPr/>
          </p:nvSpPr>
          <p:spPr>
            <a:xfrm>
              <a:off x="2216114" y="5209458"/>
              <a:ext cx="30066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0</a:t>
              </a:r>
            </a:p>
          </p:txBody>
        </p: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id="{79D154E2-D34F-4996-A38B-EE938B5568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564" r="5498" b="9593"/>
          <a:stretch/>
        </p:blipFill>
        <p:spPr>
          <a:xfrm>
            <a:off x="2947232" y="3312299"/>
            <a:ext cx="4754880" cy="1333874"/>
          </a:xfrm>
          <a:prstGeom prst="rect">
            <a:avLst/>
          </a:prstGeom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8755B795-FAB1-4874-AFD5-18029A9A716F}"/>
              </a:ext>
            </a:extLst>
          </p:cNvPr>
          <p:cNvGrpSpPr/>
          <p:nvPr/>
        </p:nvGrpSpPr>
        <p:grpSpPr>
          <a:xfrm>
            <a:off x="3038535" y="3304297"/>
            <a:ext cx="970182" cy="762345"/>
            <a:chOff x="2124889" y="4708723"/>
            <a:chExt cx="970182" cy="762345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FDA0350-C9E6-4AF1-97AD-2A82003DE249}"/>
                </a:ext>
              </a:extLst>
            </p:cNvPr>
            <p:cNvSpPr txBox="1"/>
            <p:nvPr/>
          </p:nvSpPr>
          <p:spPr>
            <a:xfrm>
              <a:off x="2201876" y="4708723"/>
              <a:ext cx="893195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3 V/cm RMS</a:t>
              </a: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EE530A80-2F7D-4615-8A9E-57A410C12F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24889" y="4815516"/>
              <a:ext cx="132109" cy="527963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40E28DD-B98D-4A80-9AE7-CA285C40E8E4}"/>
                </a:ext>
              </a:extLst>
            </p:cNvPr>
            <p:cNvSpPr txBox="1"/>
            <p:nvPr/>
          </p:nvSpPr>
          <p:spPr>
            <a:xfrm>
              <a:off x="2216114" y="5209458"/>
              <a:ext cx="30066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0</a:t>
              </a:r>
            </a:p>
          </p:txBody>
        </p: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00000000-0008-0000-0400-000005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8346" r="6407" b="24725"/>
          <a:stretch/>
        </p:blipFill>
        <p:spPr>
          <a:xfrm>
            <a:off x="2947232" y="4894049"/>
            <a:ext cx="4754880" cy="135563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B07BF91-4962-4182-B6C3-DFA1B73629BF}"/>
              </a:ext>
            </a:extLst>
          </p:cNvPr>
          <p:cNvSpPr txBox="1"/>
          <p:nvPr/>
        </p:nvSpPr>
        <p:spPr>
          <a:xfrm>
            <a:off x="4845198" y="1408499"/>
            <a:ext cx="1256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1</a:t>
            </a:r>
            <a:r>
              <a:rPr lang="en-US" sz="1600" b="1" baseline="30000" dirty="0"/>
              <a:t>st</a:t>
            </a:r>
            <a:r>
              <a:rPr lang="en-US" sz="1600" b="1" dirty="0"/>
              <a:t> array pai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A48457-D07E-49BF-A0C3-F73D511F9F76}"/>
              </a:ext>
            </a:extLst>
          </p:cNvPr>
          <p:cNvSpPr txBox="1"/>
          <p:nvPr/>
        </p:nvSpPr>
        <p:spPr>
          <a:xfrm>
            <a:off x="4791434" y="3022643"/>
            <a:ext cx="13033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2</a:t>
            </a:r>
            <a:r>
              <a:rPr lang="en-US" sz="1600" b="1" baseline="30000" dirty="0"/>
              <a:t>nd</a:t>
            </a:r>
            <a:r>
              <a:rPr lang="en-US" sz="1600" b="1" dirty="0"/>
              <a:t> array pai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2FED889-E391-4D6C-B959-8F4072F1BBA3}"/>
              </a:ext>
            </a:extLst>
          </p:cNvPr>
          <p:cNvSpPr txBox="1"/>
          <p:nvPr/>
        </p:nvSpPr>
        <p:spPr>
          <a:xfrm>
            <a:off x="5081962" y="4609063"/>
            <a:ext cx="8340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merged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7F1CC38-2CDA-47E9-AF07-D5AF7574BFEB}"/>
              </a:ext>
            </a:extLst>
          </p:cNvPr>
          <p:cNvGrpSpPr/>
          <p:nvPr/>
        </p:nvGrpSpPr>
        <p:grpSpPr>
          <a:xfrm>
            <a:off x="3013020" y="4890704"/>
            <a:ext cx="970182" cy="762345"/>
            <a:chOff x="2124889" y="4708723"/>
            <a:chExt cx="970182" cy="762345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7A9AAE4-CFD0-4EF4-B84A-651D41CCB28C}"/>
                </a:ext>
              </a:extLst>
            </p:cNvPr>
            <p:cNvSpPr txBox="1"/>
            <p:nvPr/>
          </p:nvSpPr>
          <p:spPr>
            <a:xfrm>
              <a:off x="2201876" y="4708723"/>
              <a:ext cx="893195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3 V/cm RMS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D47641C-B784-4EA1-A248-886BC0D6DC1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24889" y="4815516"/>
              <a:ext cx="132109" cy="527963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58E5198-BEEE-4E76-9548-4E1F7A952764}"/>
                </a:ext>
              </a:extLst>
            </p:cNvPr>
            <p:cNvSpPr txBox="1"/>
            <p:nvPr/>
          </p:nvSpPr>
          <p:spPr>
            <a:xfrm>
              <a:off x="2216114" y="5209458"/>
              <a:ext cx="30066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37654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97</TotalTime>
  <Words>290</Words>
  <Application>Microsoft Office PowerPoint</Application>
  <PresentationFormat>Widescreen</PresentationFormat>
  <Paragraphs>2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hristiansen</dc:creator>
  <cp:lastModifiedBy>Adi Haber</cp:lastModifiedBy>
  <cp:revision>92</cp:revision>
  <cp:lastPrinted>2020-12-28T08:37:31Z</cp:lastPrinted>
  <dcterms:created xsi:type="dcterms:W3CDTF">2019-11-14T18:23:33Z</dcterms:created>
  <dcterms:modified xsi:type="dcterms:W3CDTF">2021-06-17T16:08:01Z</dcterms:modified>
</cp:coreProperties>
</file>